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1DCB63-412D-467B-B8D3-0234C41B2FC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3B566F-1F41-4367-866D-311D6B777CD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EA4CDF-F0C6-4CB9-BA64-E3F5BA995B6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02D02D-AD93-42B4-AB0C-9ECD0DD8A95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02736A-9377-433F-B128-4A14A549133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236913-2562-404A-9496-80D05D95E34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43A233-A2B8-4F28-BB9B-53ED8FC50AC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E80594-9BC5-4919-B3A5-9B794A470F7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5FF158-E8B1-459C-8C73-EC9778A6F58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60E663-E834-43FC-9B83-0F3152F72F0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123C85-DA3B-40E5-A806-51EF528F04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0A684C-A59D-4BA3-AD42-B2B05977D4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4B38C2D-2774-4E98-9AD3-785807698E8B}" type="slidenum"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8"/>
          <p:cNvSpPr/>
          <p:nvPr/>
        </p:nvSpPr>
        <p:spPr>
          <a:xfrm>
            <a:off x="1528920" y="-36360"/>
            <a:ext cx="3816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4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42" name="그림 1" descr=""/>
          <p:cNvPicPr/>
          <p:nvPr/>
        </p:nvPicPr>
        <p:blipFill>
          <a:blip r:embed="rId1"/>
          <a:srcRect l="4199" t="7081" r="1303" b="2884"/>
          <a:stretch/>
        </p:blipFill>
        <p:spPr>
          <a:xfrm>
            <a:off x="333360" y="755640"/>
            <a:ext cx="6048360" cy="5981760"/>
          </a:xfrm>
          <a:prstGeom prst="rect">
            <a:avLst/>
          </a:prstGeom>
          <a:ln w="0">
            <a:noFill/>
          </a:ln>
        </p:spPr>
      </p:pic>
      <p:sp>
        <p:nvSpPr>
          <p:cNvPr id="43" name="TextBox 11"/>
          <p:cNvSpPr/>
          <p:nvPr/>
        </p:nvSpPr>
        <p:spPr>
          <a:xfrm>
            <a:off x="333360" y="7451640"/>
            <a:ext cx="619128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4 |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taphylococcus aureus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infection pathway in MRSA treated with NaP. The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taphylococcus aureus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infection pathway in MRSA treated with NaP is represented. Green and red highlights indicate up- and down-regulated DEGs in the assigned pathway, respectively.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625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1-30T07:45:37Z</dcterms:created>
  <dc:creator>조민경</dc:creator>
  <dc:description/>
  <dc:language>en-US</dc:language>
  <cp:lastModifiedBy>임진택</cp:lastModifiedBy>
  <cp:lastPrinted>2022-01-06T07:05:04Z</cp:lastPrinted>
  <dcterms:modified xsi:type="dcterms:W3CDTF">2022-10-04T08:53:50Z</dcterms:modified>
  <cp:revision>510</cp:revision>
  <dc:subject/>
  <dc:title>슬라이드 1</dc:title>
</cp:coreProperties>
</file>